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xlsx" ContentType="application/vnd.openxmlformats-officedocument.spreadsheetml.sheet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78" autoAdjust="0"/>
    <p:restoredTop sz="94660"/>
  </p:normalViewPr>
  <p:slideViewPr>
    <p:cSldViewPr snapToGrid="0">
      <p:cViewPr varScale="1">
        <p:scale>
          <a:sx n="142" d="100"/>
          <a:sy n="142" d="100"/>
        </p:scale>
        <p:origin x="176" y="4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1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000" b="1" baseline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 positivity in pancreatic cell lineages</a:t>
            </a:r>
            <a:endParaRPr lang="en-US" sz="1000" b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stdErr"/>
            <c:noEndCap val="0"/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!$A$2:$A$4</c:f>
              <c:strCache>
                <c:ptCount val="3"/>
                <c:pt idx="0">
                  <c:v>Ductal cells</c:v>
                </c:pt>
                <c:pt idx="1">
                  <c:v>Islet Cells</c:v>
                </c:pt>
                <c:pt idx="2">
                  <c:v>Acinar Cells</c:v>
                </c:pt>
              </c:strCache>
            </c:strRef>
          </c:cat>
          <c:val>
            <c:numRef>
              <c:f>SUM!$B$2:$B$4</c:f>
              <c:numCache>
                <c:formatCode>0.00%</c:formatCode>
                <c:ptCount val="3"/>
                <c:pt idx="0">
                  <c:v>0.3889</c:v>
                </c:pt>
                <c:pt idx="1">
                  <c:v>0.2911</c:v>
                </c:pt>
                <c:pt idx="2">
                  <c:v>0.219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5DF-4B1D-A08D-F8639FABA7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999087584"/>
        <c:axId val="-999120944"/>
      </c:barChart>
      <c:catAx>
        <c:axId val="-9990875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999120944"/>
        <c:crosses val="autoZero"/>
        <c:auto val="1"/>
        <c:lblAlgn val="ctr"/>
        <c:lblOffset val="100"/>
        <c:noMultiLvlLbl val="0"/>
      </c:catAx>
      <c:valAx>
        <c:axId val="-999120944"/>
        <c:scaling>
          <c:orientation val="minMax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9990875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10502-D081-4669-9B7F-70DA091C17EB}" type="datetimeFigureOut">
              <a:rPr lang="en-US" smtClean="0"/>
              <a:t>9/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CA9B2-A988-4ED8-B55A-131A85D4D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833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10502-D081-4669-9B7F-70DA091C17EB}" type="datetimeFigureOut">
              <a:rPr lang="en-US" smtClean="0"/>
              <a:t>9/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CA9B2-A988-4ED8-B55A-131A85D4D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4242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10502-D081-4669-9B7F-70DA091C17EB}" type="datetimeFigureOut">
              <a:rPr lang="en-US" smtClean="0"/>
              <a:t>9/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CA9B2-A988-4ED8-B55A-131A85D4D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1289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10502-D081-4669-9B7F-70DA091C17EB}" type="datetimeFigureOut">
              <a:rPr lang="en-US" smtClean="0"/>
              <a:t>9/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CA9B2-A988-4ED8-B55A-131A85D4D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82132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10502-D081-4669-9B7F-70DA091C17EB}" type="datetimeFigureOut">
              <a:rPr lang="en-US" smtClean="0"/>
              <a:t>9/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CA9B2-A988-4ED8-B55A-131A85D4D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1949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10502-D081-4669-9B7F-70DA091C17EB}" type="datetimeFigureOut">
              <a:rPr lang="en-US" smtClean="0"/>
              <a:t>9/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CA9B2-A988-4ED8-B55A-131A85D4D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3807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10502-D081-4669-9B7F-70DA091C17EB}" type="datetimeFigureOut">
              <a:rPr lang="en-US" smtClean="0"/>
              <a:t>9/9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CA9B2-A988-4ED8-B55A-131A85D4D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3926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10502-D081-4669-9B7F-70DA091C17EB}" type="datetimeFigureOut">
              <a:rPr lang="en-US" smtClean="0"/>
              <a:t>9/9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CA9B2-A988-4ED8-B55A-131A85D4D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3898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10502-D081-4669-9B7F-70DA091C17EB}" type="datetimeFigureOut">
              <a:rPr lang="en-US" smtClean="0"/>
              <a:t>9/9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CA9B2-A988-4ED8-B55A-131A85D4D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4020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10502-D081-4669-9B7F-70DA091C17EB}" type="datetimeFigureOut">
              <a:rPr lang="en-US" smtClean="0"/>
              <a:t>9/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CA9B2-A988-4ED8-B55A-131A85D4D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693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10502-D081-4669-9B7F-70DA091C17EB}" type="datetimeFigureOut">
              <a:rPr lang="en-US" smtClean="0"/>
              <a:t>9/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CA9B2-A988-4ED8-B55A-131A85D4D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9476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210502-D081-4669-9B7F-70DA091C17EB}" type="datetimeFigureOut">
              <a:rPr lang="en-US" smtClean="0"/>
              <a:t>9/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6CA9B2-A988-4ED8-B55A-131A85D4D5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39099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lc="http://schemas.openxmlformats.org/drawingml/2006/lockedCanvas" xmlns="" xmlns:a16="http://schemas.microsoft.com/office/drawing/2014/main" xmlns:xdr="http://schemas.openxmlformats.org/drawingml/2006/spreadsheetDrawing" id="{A397FC47-F07E-47BA-8F13-590914B6753A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539281" y="833791"/>
          <a:ext cx="3359011" cy="27331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908069" y="3700849"/>
            <a:ext cx="476794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A. Th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ercentage of recombination </a:t>
            </a:r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sz="1000" smtClean="0">
                <a:latin typeface="Arial" panose="020B0604020202020204" pitchFamily="34" charset="0"/>
                <a:cs typeface="Arial" panose="020B0604020202020204" pitchFamily="34" charset="0"/>
              </a:rPr>
              <a:t>the pancreas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The recombination was  quantified by percentage of GFP positive cells in three pancreatic epithelial lineages (ductal cells, islet cells and acinar cells). N=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 rot="16200000">
            <a:off x="1527362" y="2077276"/>
            <a:ext cx="19062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FP positive cells/total cell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17059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9106" y="1091682"/>
            <a:ext cx="5071872" cy="338042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291" y="1091682"/>
            <a:ext cx="5071872" cy="3380423"/>
          </a:xfrm>
          <a:prstGeom prst="rect">
            <a:avLst/>
          </a:prstGeom>
        </p:spPr>
      </p:pic>
      <p:cxnSp>
        <p:nvCxnSpPr>
          <p:cNvPr id="6" name="Straight Connector 5"/>
          <p:cNvCxnSpPr/>
          <p:nvPr/>
        </p:nvCxnSpPr>
        <p:spPr>
          <a:xfrm>
            <a:off x="5410340" y="4406102"/>
            <a:ext cx="3931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10588831" y="4406102"/>
            <a:ext cx="3931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765110" y="4603061"/>
            <a:ext cx="103058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B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presentativ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dx1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mmunohistochemistry staining demonstrates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dx1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xpression in th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ancreatic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nIN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lesions (Black arrows) of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dx1FlpO</a:t>
            </a:r>
            <a:r>
              <a:rPr lang="en-US" sz="10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ki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;FSF-Kras</a:t>
            </a:r>
            <a:r>
              <a:rPr lang="en-US" sz="10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G12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/+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; p53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frt/+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FSF–GFP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ice (scale bar: 50</a:t>
            </a:r>
            <a:r>
              <a:rPr lang="en-US" sz="1000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). 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0313435" y="1104117"/>
            <a:ext cx="8304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solidFill>
                  <a:srgbClr val="6633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x1 IHC</a:t>
            </a:r>
            <a:endParaRPr lang="en-US" sz="1000" b="1" dirty="0">
              <a:solidFill>
                <a:srgbClr val="6633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83720" y="2208999"/>
            <a:ext cx="323116" cy="231668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72713" y="1393603"/>
            <a:ext cx="323116" cy="231668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114459" y="3144553"/>
            <a:ext cx="323116" cy="231668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5635385">
            <a:off x="10440474" y="3911917"/>
            <a:ext cx="323116" cy="231668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5123733" y="1101009"/>
            <a:ext cx="842819" cy="250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solidFill>
                  <a:srgbClr val="6633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x1 IHC</a:t>
            </a:r>
            <a:endParaRPr lang="en-US" sz="1000" b="1" dirty="0">
              <a:solidFill>
                <a:srgbClr val="6633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44651" y="2103764"/>
            <a:ext cx="327938" cy="235655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59835" y="2346468"/>
            <a:ext cx="327938" cy="235655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15135" y="3857655"/>
            <a:ext cx="327938" cy="235655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54272" y="3817089"/>
            <a:ext cx="327938" cy="2356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219469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83</Words>
  <Application>Microsoft Macintosh PowerPoint</Application>
  <PresentationFormat>Widescreen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Calibri</vt:lpstr>
      <vt:lpstr>Calibri Light</vt:lpstr>
      <vt:lpstr>Symbol</vt:lpstr>
      <vt:lpstr>Arial</vt:lpstr>
      <vt:lpstr>Office Theme</vt:lpstr>
      <vt:lpstr>PowerPoint Presentation</vt:lpstr>
      <vt:lpstr>PowerPoint Presentation</vt:lpstr>
    </vt:vector>
  </TitlesOfParts>
  <Company>The Ohio State University Wexner Medical Center</Company>
  <LinksUpToDate>false</LinksUpToDate>
  <SharedDoc>false</SharedDoc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u, Jinghai</dc:creator>
  <cp:lastModifiedBy>Blake Hildreth</cp:lastModifiedBy>
  <cp:revision>7</cp:revision>
  <dcterms:created xsi:type="dcterms:W3CDTF">2017-08-30T14:18:12Z</dcterms:created>
  <dcterms:modified xsi:type="dcterms:W3CDTF">2017-09-09T17:53:19Z</dcterms:modified>
</cp:coreProperties>
</file>